
<file path=[Content_Types].xml><?xml version="1.0" encoding="utf-8"?>
<Types xmlns="http://schemas.openxmlformats.org/package/2006/content-types"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400800" cy="96932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50" d="100"/>
          <a:sy n="50" d="100"/>
        </p:scale>
        <p:origin x="-1902" y="-108"/>
      </p:cViewPr>
      <p:guideLst>
        <p:guide orient="horz" pos="3053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878A7-D6DA-42B4-AC65-1F24134B15E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7113" y="685800"/>
            <a:ext cx="22637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DA7404-68F4-45E1-A368-1C4CEC15D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250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7113" y="685800"/>
            <a:ext cx="22637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DA7404-68F4-45E1-A368-1C4CEC15D17E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2" y="3011199"/>
            <a:ext cx="5440679" cy="207777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5492859"/>
            <a:ext cx="4480560" cy="247717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80438" y="518326"/>
            <a:ext cx="1080135" cy="110261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0031" y="518326"/>
            <a:ext cx="3133727" cy="110261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22" y="6228829"/>
            <a:ext cx="5440679" cy="192519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22" y="4108428"/>
            <a:ext cx="5440679" cy="212040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0030" y="3015690"/>
            <a:ext cx="2106930" cy="85287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53641" y="3015690"/>
            <a:ext cx="2106930" cy="85287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88184"/>
            <a:ext cx="5760720" cy="161554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2" y="2169768"/>
            <a:ext cx="2828133" cy="90425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2" y="3074029"/>
            <a:ext cx="2828133" cy="55848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20" y="2169768"/>
            <a:ext cx="2829243" cy="90425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20" y="3074029"/>
            <a:ext cx="2829243" cy="558485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5" y="385937"/>
            <a:ext cx="2105819" cy="164247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6" y="385940"/>
            <a:ext cx="3578226" cy="827294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5" y="2028413"/>
            <a:ext cx="2105819" cy="663047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6785294"/>
            <a:ext cx="3840480" cy="80104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866112"/>
            <a:ext cx="3840480" cy="581596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7586340"/>
            <a:ext cx="3840480" cy="11376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88184"/>
            <a:ext cx="5760720" cy="16155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2261767"/>
            <a:ext cx="5760720" cy="63971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8984234"/>
            <a:ext cx="149352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6F17E-E358-4366-813C-AD953A2DF973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8984234"/>
            <a:ext cx="202692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8984234"/>
            <a:ext cx="149352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2E7DE-1404-4454-9FF5-10EC6BC4053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114300" y="56497"/>
            <a:ext cx="6155720" cy="9651065"/>
            <a:chOff x="549880" y="56497"/>
            <a:chExt cx="6155720" cy="9651065"/>
          </a:xfrm>
        </p:grpSpPr>
        <p:grpSp>
          <p:nvGrpSpPr>
            <p:cNvPr id="49" name="Group 25"/>
            <p:cNvGrpSpPr/>
            <p:nvPr/>
          </p:nvGrpSpPr>
          <p:grpSpPr>
            <a:xfrm>
              <a:off x="724576" y="56497"/>
              <a:ext cx="2652606" cy="6633865"/>
              <a:chOff x="1385994" y="0"/>
              <a:chExt cx="2652606" cy="6633865"/>
            </a:xfrm>
          </p:grpSpPr>
          <p:sp>
            <p:nvSpPr>
              <p:cNvPr id="61" name="Text Box 4"/>
              <p:cNvSpPr txBox="1">
                <a:spLocks noChangeArrowheads="1"/>
              </p:cNvSpPr>
              <p:nvPr/>
            </p:nvSpPr>
            <p:spPr bwMode="auto">
              <a:xfrm>
                <a:off x="1385994" y="0"/>
                <a:ext cx="396804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</a:p>
            </p:txBody>
          </p:sp>
          <p:sp>
            <p:nvSpPr>
              <p:cNvPr id="62" name="Text Box 2"/>
              <p:cNvSpPr txBox="1">
                <a:spLocks noChangeArrowheads="1"/>
              </p:cNvSpPr>
              <p:nvPr/>
            </p:nvSpPr>
            <p:spPr bwMode="auto">
              <a:xfrm>
                <a:off x="2743200" y="2899271"/>
                <a:ext cx="1295400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ele</a:t>
                </a: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tion</a:t>
                </a:r>
              </a:p>
            </p:txBody>
          </p:sp>
          <p:grpSp>
            <p:nvGrpSpPr>
              <p:cNvPr id="63" name="Group 21"/>
              <p:cNvGrpSpPr/>
              <p:nvPr/>
            </p:nvGrpSpPr>
            <p:grpSpPr>
              <a:xfrm>
                <a:off x="1822044" y="381000"/>
                <a:ext cx="1149758" cy="5719463"/>
                <a:chOff x="1828798" y="304800"/>
                <a:chExt cx="1149758" cy="5719463"/>
              </a:xfrm>
            </p:grpSpPr>
            <p:pic>
              <p:nvPicPr>
                <p:cNvPr id="68" name="Picture 5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8531" t="6516" r="32096" b="5636"/>
                <a:stretch>
                  <a:fillRect/>
                </a:stretch>
              </p:blipFill>
              <p:spPr bwMode="auto">
                <a:xfrm>
                  <a:off x="1904999" y="304800"/>
                  <a:ext cx="997357" cy="57194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69" name="Rectangle 68"/>
                <p:cNvSpPr/>
                <p:nvPr/>
              </p:nvSpPr>
              <p:spPr>
                <a:xfrm>
                  <a:off x="1828798" y="304800"/>
                  <a:ext cx="1149758" cy="342900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4" name="Rectangle 63"/>
              <p:cNvSpPr/>
              <p:nvPr/>
            </p:nvSpPr>
            <p:spPr>
              <a:xfrm>
                <a:off x="1742982" y="12035"/>
                <a:ext cx="134684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fontAlgn="base">
                  <a:spcBef>
                    <a:spcPct val="0"/>
                  </a:spcBef>
                  <a:spcAft>
                    <a:spcPts val="1000"/>
                  </a:spcAft>
                </a:pPr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Chromosome 2 </a:t>
                </a:r>
              </a:p>
            </p:txBody>
          </p:sp>
          <p:sp>
            <p:nvSpPr>
              <p:cNvPr id="65" name="Text Box 3"/>
              <p:cNvSpPr txBox="1">
                <a:spLocks noChangeArrowheads="1"/>
              </p:cNvSpPr>
              <p:nvPr/>
            </p:nvSpPr>
            <p:spPr bwMode="auto">
              <a:xfrm rot="16200000">
                <a:off x="409539" y="2899270"/>
                <a:ext cx="2484341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Chromosomal position</a:t>
                </a:r>
              </a:p>
            </p:txBody>
          </p:sp>
          <p:cxnSp>
            <p:nvCxnSpPr>
              <p:cNvPr id="66" name="Straight Arrow Connector 65"/>
              <p:cNvCxnSpPr/>
              <p:nvPr/>
            </p:nvCxnSpPr>
            <p:spPr>
              <a:xfrm>
                <a:off x="1913484" y="6150592"/>
                <a:ext cx="1005840" cy="1725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TextBox 66"/>
              <p:cNvSpPr txBox="1"/>
              <p:nvPr/>
            </p:nvSpPr>
            <p:spPr>
              <a:xfrm>
                <a:off x="1752600" y="6172200"/>
                <a:ext cx="132760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 60.4 </a:t>
                </a:r>
                <a:r>
                  <a:rPr lang="en-US" sz="1200" dirty="0" err="1" smtClean="0">
                    <a:latin typeface="Arial" pitchFamily="34" charset="0"/>
                    <a:cs typeface="Arial" pitchFamily="34" charset="0"/>
                  </a:rPr>
                  <a:t>cM</a:t>
                </a:r>
                <a:endParaRPr lang="en-US" sz="1200" dirty="0" smtClean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Genetic distance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0" name="Group 26"/>
            <p:cNvGrpSpPr/>
            <p:nvPr/>
          </p:nvGrpSpPr>
          <p:grpSpPr>
            <a:xfrm>
              <a:off x="3635752" y="56497"/>
              <a:ext cx="3069848" cy="6633865"/>
              <a:chOff x="5159753" y="0"/>
              <a:chExt cx="3069848" cy="6633865"/>
            </a:xfrm>
          </p:grpSpPr>
          <p:grpSp>
            <p:nvGrpSpPr>
              <p:cNvPr id="52" name="Group 24"/>
              <p:cNvGrpSpPr/>
              <p:nvPr/>
            </p:nvGrpSpPr>
            <p:grpSpPr>
              <a:xfrm>
                <a:off x="5498774" y="381000"/>
                <a:ext cx="1617409" cy="5711405"/>
                <a:chOff x="5498774" y="510633"/>
                <a:chExt cx="1617409" cy="5711405"/>
              </a:xfrm>
            </p:grpSpPr>
            <p:pic>
              <p:nvPicPr>
                <p:cNvPr id="59" name="Picture 58" descr="c5_lod5.emf"/>
                <p:cNvPicPr>
                  <a:picLocks noChangeAspect="1"/>
                </p:cNvPicPr>
                <p:nvPr/>
              </p:nvPicPr>
              <p:blipFill>
                <a:blip r:embed="rId4" cstate="print"/>
                <a:srcRect l="17685" t="2796" r="15547"/>
                <a:stretch>
                  <a:fillRect/>
                </a:stretch>
              </p:blipFill>
              <p:spPr>
                <a:xfrm>
                  <a:off x="5575700" y="510633"/>
                  <a:ext cx="1510900" cy="5711405"/>
                </a:xfrm>
                <a:prstGeom prst="rect">
                  <a:avLst/>
                </a:prstGeom>
              </p:spPr>
            </p:pic>
            <p:sp>
              <p:nvSpPr>
                <p:cNvPr id="60" name="Rectangle 59"/>
                <p:cNvSpPr/>
                <p:nvPr/>
              </p:nvSpPr>
              <p:spPr>
                <a:xfrm>
                  <a:off x="5498774" y="1009262"/>
                  <a:ext cx="1617409" cy="473757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sz="120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3" name="TextBox 45"/>
              <p:cNvSpPr txBox="1"/>
              <p:nvPr/>
            </p:nvSpPr>
            <p:spPr>
              <a:xfrm>
                <a:off x="5608053" y="12036"/>
                <a:ext cx="14404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Chromosome 5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4" name="Straight Arrow Connector 53"/>
              <p:cNvCxnSpPr/>
              <p:nvPr/>
            </p:nvCxnSpPr>
            <p:spPr>
              <a:xfrm>
                <a:off x="5543472" y="6150592"/>
                <a:ext cx="1490604" cy="1725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22"/>
              <p:cNvSpPr txBox="1"/>
              <p:nvPr/>
            </p:nvSpPr>
            <p:spPr>
              <a:xfrm>
                <a:off x="5643674" y="6172200"/>
                <a:ext cx="132760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91.8 </a:t>
                </a:r>
                <a:r>
                  <a:rPr lang="en-US" sz="1200" dirty="0" err="1" smtClean="0">
                    <a:latin typeface="Arial" pitchFamily="34" charset="0"/>
                    <a:cs typeface="Arial" pitchFamily="34" charset="0"/>
                  </a:rPr>
                  <a:t>cM</a:t>
                </a:r>
                <a:endParaRPr lang="en-US" sz="1200" dirty="0" smtClean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Genetic distance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Text Box 3"/>
              <p:cNvSpPr txBox="1">
                <a:spLocks noChangeArrowheads="1"/>
              </p:cNvSpPr>
              <p:nvPr/>
            </p:nvSpPr>
            <p:spPr bwMode="auto">
              <a:xfrm rot="16200000">
                <a:off x="4056082" y="2899270"/>
                <a:ext cx="2484341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Chromosomal position</a:t>
                </a:r>
              </a:p>
            </p:txBody>
          </p:sp>
          <p:sp>
            <p:nvSpPr>
              <p:cNvPr id="57" name="Text Box 2"/>
              <p:cNvSpPr txBox="1">
                <a:spLocks noChangeArrowheads="1"/>
              </p:cNvSpPr>
              <p:nvPr/>
            </p:nvSpPr>
            <p:spPr bwMode="auto">
              <a:xfrm>
                <a:off x="7162799" y="2899271"/>
                <a:ext cx="1066802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Amplification</a:t>
                </a:r>
              </a:p>
            </p:txBody>
          </p:sp>
          <p:sp>
            <p:nvSpPr>
              <p:cNvPr id="58" name="Text Box 4"/>
              <p:cNvSpPr txBox="1">
                <a:spLocks noChangeArrowheads="1"/>
              </p:cNvSpPr>
              <p:nvPr/>
            </p:nvSpPr>
            <p:spPr bwMode="auto">
              <a:xfrm>
                <a:off x="5246651" y="0"/>
                <a:ext cx="396804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1" name="Rectangle 1"/>
            <p:cNvSpPr>
              <a:spLocks noChangeArrowheads="1"/>
            </p:cNvSpPr>
            <p:nvPr/>
          </p:nvSpPr>
          <p:spPr bwMode="auto">
            <a:xfrm>
              <a:off x="549880" y="6560607"/>
              <a:ext cx="6051582" cy="31469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0" tIns="152352" rIns="0" bIns="38088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dditional file 9  – Genetic linkage in selected CNV regions. </a:t>
              </a:r>
            </a:p>
            <a:p>
              <a:pPr lvl="0" eaLnBrk="0" fontAlgn="base" hangingPunct="0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sz="1200" dirty="0" smtClean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The relationship </a:t>
              </a:r>
              <a:r>
                <a:rPr lang="en-US" sz="1200" dirty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between linkage position and genome location was assessed by QTL mapping, using relative hybridization signal per probe in segregating CNV regions as a phenotype. Each individual probe signal of segregating CNVs mapped to its closest MS marker in the published linkage map for the HB3 × Dd2 genetic cross [65], highlighting the </a:t>
              </a:r>
              <a:r>
                <a:rPr lang="en-US" sz="1200" dirty="0" err="1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colinearity</a:t>
              </a:r>
              <a:r>
                <a:rPr lang="en-US" sz="1200" dirty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of the linkage and physical genome at the CNV regions. The pattern remained true for progeny wide inheritance of A) amplified regions (e.g. </a:t>
              </a:r>
              <a:r>
                <a:rPr lang="en-US" sz="1200" dirty="0" err="1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Chr</a:t>
              </a:r>
              <a:r>
                <a:rPr lang="en-US" sz="1200" dirty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5, boxed in </a:t>
              </a:r>
              <a:r>
                <a:rPr lang="en-US" sz="1200" dirty="0" smtClean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red) </a:t>
              </a:r>
              <a:r>
                <a:rPr lang="en-US" sz="1200" dirty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s well as, B) deleted regions (e.g. </a:t>
              </a:r>
              <a:r>
                <a:rPr lang="en-US" sz="1200" dirty="0" err="1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Chr</a:t>
              </a:r>
              <a:r>
                <a:rPr lang="en-US" sz="1200" dirty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2, boxed in </a:t>
              </a:r>
              <a:r>
                <a:rPr lang="en-US" sz="1200" dirty="0" smtClean="0"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red)</a:t>
              </a:r>
              <a:r>
                <a:rPr kumimoji="0" lang="en-GB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. </a:t>
              </a:r>
              <a:endParaRPr kumimoji="0" lang="en-GB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45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</cp:lastModifiedBy>
  <cp:revision>6</cp:revision>
  <dcterms:created xsi:type="dcterms:W3CDTF">2011-07-04T05:22:03Z</dcterms:created>
  <dcterms:modified xsi:type="dcterms:W3CDTF">2011-08-18T18:41:27Z</dcterms:modified>
</cp:coreProperties>
</file>